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B042F-198C-43E4-BC12-781AB6E97B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B911E-2F63-40DF-BD22-CBFA96DB0A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0A721-1628-4C6D-9116-B9F083322A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E0CDC-23D2-44C4-BDB7-DEEC77DB54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7FBE5-7D95-4AB5-B1EF-C7F3639C0E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6AB50-76D8-4FEB-B4D3-E74F236E07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0C646-5A93-4DAA-BE94-1DD399B0B2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0D35C-DB97-4FB2-9B67-357C3A3062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7F45A-1391-41B1-A577-25A8FFC625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2C391-9BF9-4791-B627-3FF5EFC67A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FE9CA-C2B6-4A8A-9FAE-06EEB7C80F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883B37-7005-4F86-9630-9F207F8B9F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93EB7D-00DD-45A1-AA6F-9D0F77D92046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-252360" y="-47520"/>
          <a:ext cx="936720" cy="274680"/>
        </p:xfrm>
        <a:graphic>
          <a:graphicData uri="http://schemas.openxmlformats.org/drawingml/2006/table">
            <a:tbl>
              <a:tblPr/>
              <a:tblGrid>
                <a:gridCol w="936720"/>
              </a:tblGrid>
              <a:tr h="27468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251000" y="3875040"/>
          <a:ext cx="936720" cy="274680"/>
        </p:xfrm>
        <a:graphic>
          <a:graphicData uri="http://schemas.openxmlformats.org/drawingml/2006/table">
            <a:tbl>
              <a:tblPr/>
              <a:tblGrid>
                <a:gridCol w="936720"/>
              </a:tblGrid>
              <a:tr h="27468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 Box 111"/>
          <p:cNvSpPr/>
          <p:nvPr/>
        </p:nvSpPr>
        <p:spPr>
          <a:xfrm>
            <a:off x="4042080" y="3863880"/>
            <a:ext cx="175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Patient 1, CT scan da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12"/>
          <p:cNvSpPr/>
          <p:nvPr/>
        </p:nvSpPr>
        <p:spPr>
          <a:xfrm>
            <a:off x="3494160" y="4127400"/>
            <a:ext cx="72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05/14/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13"/>
          <p:cNvSpPr/>
          <p:nvPr/>
        </p:nvSpPr>
        <p:spPr>
          <a:xfrm>
            <a:off x="5791320" y="4127400"/>
            <a:ext cx="72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07/23/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14"/>
          <p:cNvSpPr/>
          <p:nvPr/>
        </p:nvSpPr>
        <p:spPr>
          <a:xfrm>
            <a:off x="4140360" y="4138560"/>
            <a:ext cx="1655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 115"/>
          <p:cNvGrpSpPr/>
          <p:nvPr/>
        </p:nvGrpSpPr>
        <p:grpSpPr>
          <a:xfrm>
            <a:off x="2340000" y="4448160"/>
            <a:ext cx="5217480" cy="2036160"/>
            <a:chOff x="2340000" y="4448160"/>
            <a:chExt cx="5217480" cy="2036160"/>
          </a:xfrm>
        </p:grpSpPr>
        <p:grpSp>
          <p:nvGrpSpPr>
            <p:cNvPr id="48" name="Group 116"/>
            <p:cNvGrpSpPr/>
            <p:nvPr/>
          </p:nvGrpSpPr>
          <p:grpSpPr>
            <a:xfrm>
              <a:off x="2340000" y="4448160"/>
              <a:ext cx="5217480" cy="2036160"/>
              <a:chOff x="2340000" y="4448160"/>
              <a:chExt cx="5217480" cy="2036160"/>
            </a:xfrm>
          </p:grpSpPr>
          <p:pic>
            <p:nvPicPr>
              <p:cNvPr id="49" name="Picture 117" descr="AD (patient 1)_pre-scan"/>
              <p:cNvPicPr/>
              <p:nvPr/>
            </p:nvPicPr>
            <p:blipFill>
              <a:blip r:embed="rId1"/>
              <a:stretch/>
            </p:blipFill>
            <p:spPr>
              <a:xfrm>
                <a:off x="2340000" y="4448160"/>
                <a:ext cx="2619360" cy="2036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Picture 118" descr="AD (patient 1)_post_scan"/>
              <p:cNvPicPr/>
              <p:nvPr/>
            </p:nvPicPr>
            <p:blipFill>
              <a:blip r:embed="rId2"/>
              <a:stretch/>
            </p:blipFill>
            <p:spPr>
              <a:xfrm>
                <a:off x="4971960" y="4448160"/>
                <a:ext cx="2585520" cy="20325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1" name="Line 119"/>
            <p:cNvSpPr/>
            <p:nvPr/>
          </p:nvSpPr>
          <p:spPr>
            <a:xfrm flipH="1" flipV="1">
              <a:off x="2549160" y="5100120"/>
              <a:ext cx="544320" cy="17316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20"/>
            <p:cNvSpPr/>
            <p:nvPr/>
          </p:nvSpPr>
          <p:spPr>
            <a:xfrm flipH="1" flipV="1">
              <a:off x="5216400" y="5025960"/>
              <a:ext cx="544320" cy="17316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 Box 121"/>
          <p:cNvSpPr/>
          <p:nvPr/>
        </p:nvSpPr>
        <p:spPr>
          <a:xfrm>
            <a:off x="3470400" y="6539040"/>
            <a:ext cx="434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The arrow points at the axillary lymph nod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33"/>
          <p:cNvSpPr/>
          <p:nvPr/>
        </p:nvSpPr>
        <p:spPr>
          <a:xfrm>
            <a:off x="674640" y="320760"/>
            <a:ext cx="8542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1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Nab-paclitaxel, trastuzumab, pertuzumab           05/14/18      07/23/18       Partial Response                   05.24, 06.15, 07.06, 07.27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34"/>
          <p:cNvSpPr/>
          <p:nvPr/>
        </p:nvSpPr>
        <p:spPr>
          <a:xfrm>
            <a:off x="674640" y="1135080"/>
            <a:ext cx="872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3                        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T-DM1                                  06/11/18       10/24/18        Stable Disease on T-DM1    07.27, 08.18, 09.07, 10.05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35"/>
          <p:cNvSpPr/>
          <p:nvPr/>
        </p:nvSpPr>
        <p:spPr>
          <a:xfrm>
            <a:off x="674640" y="1474920"/>
            <a:ext cx="846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4              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Trastuzumab, pertuzumab              05/04/18       10/19/18       Stable Disease                       06.19, 07.13, 08.03, 08.2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36"/>
          <p:cNvSpPr/>
          <p:nvPr/>
        </p:nvSpPr>
        <p:spPr>
          <a:xfrm>
            <a:off x="674640" y="1879560"/>
            <a:ext cx="8469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5                      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Trastuzumab                           06/14/18       09/25/18       Stable Disease                       06.22, 07.13, 08. 03, 08.24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37"/>
          <p:cNvSpPr/>
          <p:nvPr/>
        </p:nvSpPr>
        <p:spPr>
          <a:xfrm>
            <a:off x="674640" y="2265480"/>
            <a:ext cx="846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6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Nab-paclitaxel, trastuzumab, pertuzumab     06/07/18       08/30/18       Progressive Disease              06.27, 07.18, 08.08, 08.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38"/>
          <p:cNvSpPr/>
          <p:nvPr/>
        </p:nvSpPr>
        <p:spPr>
          <a:xfrm>
            <a:off x="674640" y="2697120"/>
            <a:ext cx="8361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7 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Capecitabine, trastuzumab, pertuzumab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06/07/18       12/12/18        Stable Disease                      08.18, 08.31, 09.21, 10.02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39"/>
          <p:cNvSpPr/>
          <p:nvPr/>
        </p:nvSpPr>
        <p:spPr>
          <a:xfrm>
            <a:off x="684360" y="3130560"/>
            <a:ext cx="8469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8               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Trastuzumab, pertuzumab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08/21/18       12/18/18        Stable Disease                       10.10, 10.31, 11.21, 12.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40"/>
          <p:cNvSpPr/>
          <p:nvPr/>
        </p:nvSpPr>
        <p:spPr>
          <a:xfrm>
            <a:off x="490320" y="-38160"/>
            <a:ext cx="8707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Patient's ID               Treatment regimen                   CT scan 1    CT scan 2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Response                      Blood collection dates, 20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34"/>
          <p:cNvSpPr/>
          <p:nvPr/>
        </p:nvSpPr>
        <p:spPr>
          <a:xfrm>
            <a:off x="674640" y="779400"/>
            <a:ext cx="846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2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Nab-paclitaxel, trastuzumab, pertuzumab         07/05/18      17/08/18       Stable Disease                       05.28, 06.19, 07.10, 07.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39"/>
          <p:cNvSpPr/>
          <p:nvPr/>
        </p:nvSpPr>
        <p:spPr>
          <a:xfrm>
            <a:off x="693720" y="3513240"/>
            <a:ext cx="846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9                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Trastuzumab, pertuzumab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10/01/18        06/13/19        Stable Disease                      10.11, 11.01, 11.22, 12.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8-14T01:48:00Z</dcterms:created>
  <dc:creator>krosen</dc:creator>
  <dc:description/>
  <dc:language>en-US</dc:language>
  <cp:lastModifiedBy>Kirill Rosen</cp:lastModifiedBy>
  <dcterms:modified xsi:type="dcterms:W3CDTF">2020-08-14T17:22:25Z</dcterms:modified>
  <cp:revision>42</cp:revision>
  <dc:subject/>
  <dc:title>Slide 1</dc:title>
</cp:coreProperties>
</file>